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12"/>
  </p:notesMasterIdLst>
  <p:sldIdLst>
    <p:sldId id="330" r:id="rId2"/>
    <p:sldId id="343" r:id="rId3"/>
    <p:sldId id="322" r:id="rId4"/>
    <p:sldId id="326" r:id="rId5"/>
    <p:sldId id="344" r:id="rId6"/>
    <p:sldId id="345" r:id="rId7"/>
    <p:sldId id="339" r:id="rId8"/>
    <p:sldId id="335" r:id="rId9"/>
    <p:sldId id="336" r:id="rId10"/>
    <p:sldId id="337" r:id="rId11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160" userDrawn="1">
          <p15:clr>
            <a:srgbClr val="A4A3A4"/>
          </p15:clr>
        </p15:guide>
        <p15:guide id="2" orient="horz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A5143"/>
    <a:srgbClr val="C66A49"/>
    <a:srgbClr val="373FC6"/>
    <a:srgbClr val="007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0505E3EF-67EA-436B-97B2-0124C06EBD24}" styleName="Medium Style 4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10"/>
    <p:restoredTop sz="97780"/>
  </p:normalViewPr>
  <p:slideViewPr>
    <p:cSldViewPr snapToGrid="0" snapToObjects="1">
      <p:cViewPr varScale="1">
        <p:scale>
          <a:sx n="91" d="100"/>
          <a:sy n="91" d="100"/>
        </p:scale>
        <p:origin x="3464" y="184"/>
      </p:cViewPr>
      <p:guideLst>
        <p:guide pos="2160"/>
        <p:guide orient="horz" pos="312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P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F75AA1-BA44-BE46-97AC-15B28205497D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P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B15DD8-90EC-6947-8FA7-26523E1AF577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461186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B15DD8-90EC-6947-8FA7-26523E1AF577}" type="slidenum">
              <a:rPr lang="en-PT" smtClean="0"/>
              <a:t>3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61229250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B15DD8-90EC-6947-8FA7-26523E1AF577}" type="slidenum">
              <a:rPr lang="en-PT" smtClean="0"/>
              <a:t>4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51787194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6B15DD8-90EC-6947-8FA7-26523E1AF577}" type="slidenum">
              <a:rPr lang="en-PT" smtClean="0"/>
              <a:t>6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3541468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839289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274626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7286612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386770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9117628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1093643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285462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1439153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463565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2440907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347920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E11070-0E4C-5C4E-B67E-3829ACE0E26C}" type="datetimeFigureOut">
              <a:rPr lang="en-PT" smtClean="0"/>
              <a:t>23/07/2023</a:t>
            </a:fld>
            <a:endParaRPr lang="en-P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E90BE0-EF9E-404A-B3D6-2B8B2785C5C9}" type="slidenum">
              <a:rPr lang="en-PT" smtClean="0"/>
              <a:t>‹#›</a:t>
            </a:fld>
            <a:endParaRPr lang="en-PT"/>
          </a:p>
        </p:txBody>
      </p:sp>
    </p:spTree>
    <p:extLst>
      <p:ext uri="{BB962C8B-B14F-4D97-AF65-F5344CB8AC3E}">
        <p14:creationId xmlns:p14="http://schemas.microsoft.com/office/powerpoint/2010/main" val="4234517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FF94540-C23C-E04C-93DD-1557167B2903}"/>
              </a:ext>
            </a:extLst>
          </p:cNvPr>
          <p:cNvSpPr/>
          <p:nvPr/>
        </p:nvSpPr>
        <p:spPr>
          <a:xfrm>
            <a:off x="33452" y="46306"/>
            <a:ext cx="679109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1100" dirty="0">
                <a:latin typeface="Helvetica" pitchFamily="2" charset="0"/>
              </a:rPr>
              <a:t>Table S1: Susceptibility and protective HLA class II genotypes in EOT1D and LaOT1D.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3A30200-0C75-5247-AD48-6F8C994D2AE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92953104"/>
              </p:ext>
            </p:extLst>
          </p:nvPr>
        </p:nvGraphicFramePr>
        <p:xfrm>
          <a:off x="145932" y="358811"/>
          <a:ext cx="6579483" cy="4154394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54092">
                  <a:extLst>
                    <a:ext uri="{9D8B030D-6E8A-4147-A177-3AD203B41FA5}">
                      <a16:colId xmlns:a16="http://schemas.microsoft.com/office/drawing/2014/main" val="3635169261"/>
                    </a:ext>
                  </a:extLst>
                </a:gridCol>
                <a:gridCol w="837873">
                  <a:extLst>
                    <a:ext uri="{9D8B030D-6E8A-4147-A177-3AD203B41FA5}">
                      <a16:colId xmlns:a16="http://schemas.microsoft.com/office/drawing/2014/main" val="3211622722"/>
                    </a:ext>
                  </a:extLst>
                </a:gridCol>
                <a:gridCol w="692978">
                  <a:extLst>
                    <a:ext uri="{9D8B030D-6E8A-4147-A177-3AD203B41FA5}">
                      <a16:colId xmlns:a16="http://schemas.microsoft.com/office/drawing/2014/main" val="2546806782"/>
                    </a:ext>
                  </a:extLst>
                </a:gridCol>
                <a:gridCol w="709008">
                  <a:extLst>
                    <a:ext uri="{9D8B030D-6E8A-4147-A177-3AD203B41FA5}">
                      <a16:colId xmlns:a16="http://schemas.microsoft.com/office/drawing/2014/main" val="1422447220"/>
                    </a:ext>
                  </a:extLst>
                </a:gridCol>
                <a:gridCol w="821383">
                  <a:extLst>
                    <a:ext uri="{9D8B030D-6E8A-4147-A177-3AD203B41FA5}">
                      <a16:colId xmlns:a16="http://schemas.microsoft.com/office/drawing/2014/main" val="458706664"/>
                    </a:ext>
                  </a:extLst>
                </a:gridCol>
                <a:gridCol w="821383">
                  <a:extLst>
                    <a:ext uri="{9D8B030D-6E8A-4147-A177-3AD203B41FA5}">
                      <a16:colId xmlns:a16="http://schemas.microsoft.com/office/drawing/2014/main" val="406052237"/>
                    </a:ext>
                  </a:extLst>
                </a:gridCol>
                <a:gridCol w="821383">
                  <a:extLst>
                    <a:ext uri="{9D8B030D-6E8A-4147-A177-3AD203B41FA5}">
                      <a16:colId xmlns:a16="http://schemas.microsoft.com/office/drawing/2014/main" val="1104970003"/>
                    </a:ext>
                  </a:extLst>
                </a:gridCol>
                <a:gridCol w="821383">
                  <a:extLst>
                    <a:ext uri="{9D8B030D-6E8A-4147-A177-3AD203B41FA5}">
                      <a16:colId xmlns:a16="http://schemas.microsoft.com/office/drawing/2014/main" val="1059815112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Genotypes</a:t>
                      </a:r>
                      <a:endParaRPr lang="en-PT" sz="800" b="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  <a:endParaRPr lang="en-PT" sz="800" b="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61296549"/>
                  </a:ext>
                </a:extLst>
              </a:tr>
              <a:tr h="205740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3/DR4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9 (19.8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4 (35.1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41.4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6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3.5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6628326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90.6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0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8.9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4222769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3/3 or DR4/4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9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 (12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17.3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8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9.8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80140229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23.7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1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5.9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110410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3/DR3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 (7.3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1 (11.3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13.2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9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dirty="0">
                          <a:latin typeface="Helvetica" pitchFamily="2" charset="0"/>
                        </a:rPr>
                        <a:t>NS</a:t>
                      </a:r>
                      <a:endParaRPr lang="en-PT" sz="900" b="0" baseline="300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95321601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3/DR3</a:t>
                      </a: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21.4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6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5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41974595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DR4/DR4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 (2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1.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3.5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7272240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1.7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80840373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DR3/X or DR4/X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6 (27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7 (59.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5 (46.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9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5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9.16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704976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3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9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2.96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8182090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3/X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2 (13.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7 (28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2 (22.7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6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0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4.2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488223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.9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89570407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4/X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4 (14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0 (31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3 (23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7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3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2.2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8126752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.8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4946788"/>
                  </a:ext>
                </a:extLst>
              </a:tr>
              <a:tr h="124199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X/X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3 (72.8)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1 (11.5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 (6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8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8.8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54715286"/>
                  </a:ext>
                </a:extLst>
              </a:tr>
              <a:tr h="124199"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5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3.7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4493996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8B7CFB34-FD7B-1342-B805-79AC4030FB8C}"/>
              </a:ext>
            </a:extLst>
          </p:cNvPr>
          <p:cNvSpPr txBox="1"/>
          <p:nvPr/>
        </p:nvSpPr>
        <p:spPr>
          <a:xfrm>
            <a:off x="139256" y="4564100"/>
            <a:ext cx="6579483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and frequency of genotypes in 169 control subjects, 96 LaOT1D subjects and 97 EOT1D subjects. </a:t>
            </a:r>
          </a:p>
          <a:p>
            <a:pPr algn="just"/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 significant. For genotypes absent in HC, the value of n=1 was considered to calculate the OR. </a:t>
            </a:r>
          </a:p>
          <a:p>
            <a:pPr algn="just"/>
            <a:r>
              <a:rPr lang="en-GB" sz="900" dirty="0">
                <a:latin typeface="Helvetica" pitchFamily="2" charset="0"/>
              </a:rPr>
              <a:t>DR3: DRB1*03:01-DQA1*05:01-DQB1*02:01 haplotype. </a:t>
            </a:r>
          </a:p>
          <a:p>
            <a:pPr algn="just"/>
            <a:r>
              <a:rPr lang="en-GB" sz="900" dirty="0">
                <a:latin typeface="Helvetica" pitchFamily="2" charset="0"/>
              </a:rPr>
              <a:t>DR4: DRB1*04:01/04:02/04:04/04:05/04:08-DQA1*03:01/03:02-DQB1*03:02 haplotypes.</a:t>
            </a:r>
          </a:p>
          <a:p>
            <a:pPr algn="just"/>
            <a:r>
              <a:rPr lang="en-GB" sz="900" dirty="0">
                <a:latin typeface="Helvetica" pitchFamily="2" charset="0"/>
              </a:rPr>
              <a:t>X: other haplotypes than DR3 or DR4.  </a:t>
            </a:r>
          </a:p>
        </p:txBody>
      </p:sp>
    </p:spTree>
    <p:extLst>
      <p:ext uri="{BB962C8B-B14F-4D97-AF65-F5344CB8AC3E}">
        <p14:creationId xmlns:p14="http://schemas.microsoft.com/office/powerpoint/2010/main" val="23334018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360476F3-568D-E52C-6FBD-10C6608AADDB}"/>
              </a:ext>
            </a:extLst>
          </p:cNvPr>
          <p:cNvSpPr/>
          <p:nvPr/>
        </p:nvSpPr>
        <p:spPr>
          <a:xfrm>
            <a:off x="49096" y="106395"/>
            <a:ext cx="675674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1000" dirty="0">
                <a:latin typeface="Helvetica" pitchFamily="2" charset="0"/>
              </a:rPr>
              <a:t>Table S10: Risk and protective haplotypes defined by HLA-DQB1 position 57, HLA-DRB1 position 13 and HLA-DRB1 position 71 in EOT1D and LaOT1D.</a:t>
            </a:r>
            <a:endParaRPr lang="en-PT" sz="100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DCCFFF9-0EA5-3D61-DC3B-C82F152D196B}"/>
              </a:ext>
            </a:extLst>
          </p:cNvPr>
          <p:cNvGraphicFramePr>
            <a:graphicFrameLocks noGrp="1"/>
          </p:cNvGraphicFramePr>
          <p:nvPr/>
        </p:nvGraphicFramePr>
        <p:xfrm>
          <a:off x="213060" y="594121"/>
          <a:ext cx="6450733" cy="3974352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28031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684650">
                  <a:extLst>
                    <a:ext uri="{9D8B030D-6E8A-4147-A177-3AD203B41FA5}">
                      <a16:colId xmlns:a16="http://schemas.microsoft.com/office/drawing/2014/main" val="3113448806"/>
                    </a:ext>
                  </a:extLst>
                </a:gridCol>
                <a:gridCol w="806342">
                  <a:extLst>
                    <a:ext uri="{9D8B030D-6E8A-4147-A177-3AD203B41FA5}">
                      <a16:colId xmlns:a16="http://schemas.microsoft.com/office/drawing/2014/main" val="3087413258"/>
                    </a:ext>
                  </a:extLst>
                </a:gridCol>
                <a:gridCol w="806342">
                  <a:extLst>
                    <a:ext uri="{9D8B030D-6E8A-4147-A177-3AD203B41FA5}">
                      <a16:colId xmlns:a16="http://schemas.microsoft.com/office/drawing/2014/main" val="267998112"/>
                    </a:ext>
                  </a:extLst>
                </a:gridCol>
                <a:gridCol w="806342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06342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13899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798785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Haplotyp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dirty="0">
                          <a:latin typeface="Helvetica" pitchFamily="2" charset="0"/>
                        </a:rPr>
                        <a:t>Risk haplotype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912005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A-H-K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 (1.5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 (10.4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2 (11.3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7.7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9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4.5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5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1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9.2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535227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A-S-K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1 (6.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2 (32.3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8 (40.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7.2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9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7.1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72909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0.1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1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9.3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3096666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algn="ctr"/>
                      <a:r>
                        <a:rPr lang="en-PT" sz="1000" dirty="0">
                          <a:latin typeface="Helvetica" pitchFamily="2" charset="0"/>
                        </a:rPr>
                        <a:t>Protective haplotypes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7498534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-G-R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8 (5.3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0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2.2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5748201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.6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0" dirty="0">
                          <a:latin typeface="Helvetica" pitchFamily="2" charset="0"/>
                        </a:rPr>
                        <a:t>NS</a:t>
                      </a:r>
                      <a:endParaRPr lang="en-PT" sz="900" b="0" baseline="300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6859323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-R-A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4 (7.1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5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9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2.2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320588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.7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5265331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D-S-E</a:t>
                      </a:r>
                    </a:p>
                  </a:txBody>
                  <a:tcPr anchor="ctr"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9 (8.6)</a:t>
                      </a:r>
                    </a:p>
                  </a:txBody>
                  <a:tcPr anchor="ctr"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 (2.6)</a:t>
                      </a:r>
                    </a:p>
                  </a:txBody>
                  <a:tcPr anchor="ctr"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5)</a:t>
                      </a:r>
                    </a:p>
                  </a:txBody>
                  <a:tcPr anchor="ctr">
                    <a:lnB>
                      <a:noFill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.65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0" dirty="0">
                          <a:latin typeface="Helvetica" pitchFamily="2" charset="0"/>
                        </a:rPr>
                        <a:t>NS</a:t>
                      </a:r>
                      <a:endParaRPr lang="en-PT" sz="900" b="0" baseline="300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15345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.4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3.8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910379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-S-R</a:t>
                      </a: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1 (12.1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 (3.1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L>
                      <a:noFill/>
                    </a:lnL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6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2.6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4627723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L>
                      <a:noFill/>
                    </a:lnL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1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8.70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3558800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5DD75F0-A68B-E6DC-AB63-AB6957FC0578}"/>
              </a:ext>
            </a:extLst>
          </p:cNvPr>
          <p:cNvSpPr txBox="1"/>
          <p:nvPr/>
        </p:nvSpPr>
        <p:spPr>
          <a:xfrm>
            <a:off x="49096" y="4676001"/>
            <a:ext cx="6808904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00" dirty="0">
                <a:latin typeface="Helvetica" pitchFamily="2" charset="0"/>
              </a:rPr>
              <a:t>n (%): number and frequency of haplotypes in 169 control subjects, 96 LaOT1D subjects and 97 EOT1D subjects. </a:t>
            </a:r>
            <a:r>
              <a:rPr lang="en-PT" sz="1000" dirty="0">
                <a:latin typeface="Helvetica" pitchFamily="2" charset="0"/>
              </a:rPr>
              <a:t>OR: Odds ratio; p-value, uncorrected; p-value (corrected), </a:t>
            </a:r>
            <a:r>
              <a:rPr lang="en-GB" sz="1000" dirty="0">
                <a:latin typeface="Helvetica" pitchFamily="2" charset="0"/>
              </a:rPr>
              <a:t>Holm-Bonferroni multi-comparison </a:t>
            </a:r>
            <a:r>
              <a:rPr lang="en-PT" sz="1000" dirty="0">
                <a:latin typeface="Helvetica" pitchFamily="2" charset="0"/>
              </a:rPr>
              <a:t>correction</a:t>
            </a:r>
            <a:r>
              <a:rPr lang="en-GB" sz="1000" dirty="0">
                <a:latin typeface="Helvetica" pitchFamily="2" charset="0"/>
              </a:rPr>
              <a:t>. Significant results are depicted in bold. NS, non significant. </a:t>
            </a:r>
          </a:p>
        </p:txBody>
      </p:sp>
    </p:spTree>
    <p:extLst>
      <p:ext uri="{BB962C8B-B14F-4D97-AF65-F5344CB8AC3E}">
        <p14:creationId xmlns:p14="http://schemas.microsoft.com/office/powerpoint/2010/main" val="9038896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2">
            <a:extLst>
              <a:ext uri="{FF2B5EF4-FFF2-40B4-BE49-F238E27FC236}">
                <a16:creationId xmlns:a16="http://schemas.microsoft.com/office/drawing/2014/main" id="{21C491C7-3304-E147-B470-80E42406F0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97376449"/>
              </p:ext>
            </p:extLst>
          </p:nvPr>
        </p:nvGraphicFramePr>
        <p:xfrm>
          <a:off x="251012" y="506505"/>
          <a:ext cx="6529053" cy="5464734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32828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666880">
                  <a:extLst>
                    <a:ext uri="{9D8B030D-6E8A-4147-A177-3AD203B41FA5}">
                      <a16:colId xmlns:a16="http://schemas.microsoft.com/office/drawing/2014/main" val="3113448806"/>
                    </a:ext>
                  </a:extLst>
                </a:gridCol>
                <a:gridCol w="748685">
                  <a:extLst>
                    <a:ext uri="{9D8B030D-6E8A-4147-A177-3AD203B41FA5}">
                      <a16:colId xmlns:a16="http://schemas.microsoft.com/office/drawing/2014/main" val="3087413258"/>
                    </a:ext>
                  </a:extLst>
                </a:gridCol>
                <a:gridCol w="816132">
                  <a:extLst>
                    <a:ext uri="{9D8B030D-6E8A-4147-A177-3AD203B41FA5}">
                      <a16:colId xmlns:a16="http://schemas.microsoft.com/office/drawing/2014/main" val="267998112"/>
                    </a:ext>
                  </a:extLst>
                </a:gridCol>
                <a:gridCol w="816132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16132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23781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08483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Alle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3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3 (6.8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1 (31.8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8 (40.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3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.5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8.3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.2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.3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7.6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535227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4:01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2.7)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 (10.4)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1 (10.8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2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6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26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572909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4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.4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7.0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5309666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4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2.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 (6.2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5 (7.7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7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1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515676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4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.4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339838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4:04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 (1.8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0 (5.2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6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4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5748201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6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6859323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4:05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2.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9 (9.9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5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9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3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9320588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>
                          <a:latin typeface="Helvetica" pitchFamily="2" charset="0"/>
                        </a:rPr>
                        <a:t>3.02x10</a:t>
                      </a:r>
                      <a:r>
                        <a:rPr lang="en-PT" sz="900" baseline="30000">
                          <a:latin typeface="Helvetica" pitchFamily="2" charset="0"/>
                        </a:rPr>
                        <a:t>-02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5265331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4:08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3)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 (10.3)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.7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0495602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8.7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2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7.0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4228277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3:01/</a:t>
                      </a: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*03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0 (14.8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7 (34.9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7 (34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09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0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4.9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4627723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.3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5.1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6355880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5:01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6 (7.7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4 (33.3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1 (41.8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0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4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3.8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259076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6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6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4.5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328218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B1*02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2 (6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0 (36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0 (46.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2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7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3.06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8359984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2.4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2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90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590620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B1*03:02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2 (9.5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5 (28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1 (31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8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25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6.9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03431303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3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8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6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6898009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16D2D761-F9E0-1C4D-9110-FC33F9A792BA}"/>
              </a:ext>
            </a:extLst>
          </p:cNvPr>
          <p:cNvSpPr txBox="1"/>
          <p:nvPr/>
        </p:nvSpPr>
        <p:spPr>
          <a:xfrm>
            <a:off x="122179" y="6007782"/>
            <a:ext cx="66578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and frequency of alleles in 169 control subjects, 96 LaOT1D subjects and 97 EOT1D subjects. Alleles shown have an allelic frequency ≥2.5% in patients (EOT1D and LaOT1D) or in controls. DQA1*03:01 and DQA1*03:02 alleles were pooled, as either with DQB1*02:01 constitute the DQ8 molecule. </a:t>
            </a:r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-significant. 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3E85EB30-A604-6248-9F61-CEC760A5BB6C}"/>
              </a:ext>
            </a:extLst>
          </p:cNvPr>
          <p:cNvSpPr/>
          <p:nvPr/>
        </p:nvSpPr>
        <p:spPr>
          <a:xfrm>
            <a:off x="141228" y="75618"/>
            <a:ext cx="667567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1100" dirty="0">
                <a:latin typeface="Helvetica" pitchFamily="2" charset="0"/>
              </a:rPr>
              <a:t>Table S2: HLA-DRB1, HLA-DQA1 and HLA-DQB1 susceptibility alleles in EOT1D and LaOT1D.</a:t>
            </a:r>
            <a:endParaRPr lang="en-PT" sz="1100" dirty="0"/>
          </a:p>
        </p:txBody>
      </p:sp>
    </p:spTree>
    <p:extLst>
      <p:ext uri="{BB962C8B-B14F-4D97-AF65-F5344CB8AC3E}">
        <p14:creationId xmlns:p14="http://schemas.microsoft.com/office/powerpoint/2010/main" val="3643069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2">
            <a:extLst>
              <a:ext uri="{FF2B5EF4-FFF2-40B4-BE49-F238E27FC236}">
                <a16:creationId xmlns:a16="http://schemas.microsoft.com/office/drawing/2014/main" id="{21C491C7-3304-E147-B470-80E42406F0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87139832"/>
              </p:ext>
            </p:extLst>
          </p:nvPr>
        </p:nvGraphicFramePr>
        <p:xfrm>
          <a:off x="218354" y="506505"/>
          <a:ext cx="6465758" cy="49679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30193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686245">
                  <a:extLst>
                    <a:ext uri="{9D8B030D-6E8A-4147-A177-3AD203B41FA5}">
                      <a16:colId xmlns:a16="http://schemas.microsoft.com/office/drawing/2014/main" val="3113448806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3087413258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267998112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08220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Alleles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07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3 (15.7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8 (9.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6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5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6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172775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7.1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3.5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077936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RB1*15:01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3 (6.8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5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7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2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4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786227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95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6905498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1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0 (17.8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0 (5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.8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4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2572915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6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3.1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391437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1:03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7 (8.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 (2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4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2.30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75297002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2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2322904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2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3 (15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8 (9.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5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.6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55144132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.1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3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7077317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A1*05:05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9 (14.5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0 (5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.6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4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6031453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.95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1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7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7805372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B1*02:02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0 (14.8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4 (12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8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4570050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.8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3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7120052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B1*03:01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0 (17.8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4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 (2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6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7.6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354608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4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dirty="0">
                          <a:latin typeface="Helvetica" pitchFamily="2" charset="0"/>
                        </a:rPr>
                        <a:t>1.4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1198944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QB1*06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1 (6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9.7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2.7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51543070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9.7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2.7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4296735"/>
                  </a:ext>
                </a:extLst>
              </a:tr>
            </a:tbl>
          </a:graphicData>
        </a:graphic>
      </p:graphicFrame>
      <p:sp>
        <p:nvSpPr>
          <p:cNvPr id="12" name="Rectangle 11">
            <a:extLst>
              <a:ext uri="{FF2B5EF4-FFF2-40B4-BE49-F238E27FC236}">
                <a16:creationId xmlns:a16="http://schemas.microsoft.com/office/drawing/2014/main" id="{3E85EB30-A604-6248-9F61-CEC760A5BB6C}"/>
              </a:ext>
            </a:extLst>
          </p:cNvPr>
          <p:cNvSpPr/>
          <p:nvPr/>
        </p:nvSpPr>
        <p:spPr>
          <a:xfrm>
            <a:off x="130342" y="75618"/>
            <a:ext cx="667567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1100" dirty="0">
                <a:latin typeface="Helvetica" pitchFamily="2" charset="0"/>
              </a:rPr>
              <a:t>Table S3: HLA-DRB1, HLA-DQA1 and HLA-DQB1 protective alleles in EOT1D and LaOT1D.</a:t>
            </a:r>
            <a:endParaRPr lang="en-PT" sz="11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4131D48-FA48-2C4C-8590-FAD457D89BB6}"/>
              </a:ext>
            </a:extLst>
          </p:cNvPr>
          <p:cNvSpPr/>
          <p:nvPr/>
        </p:nvSpPr>
        <p:spPr>
          <a:xfrm>
            <a:off x="152475" y="5523359"/>
            <a:ext cx="6575542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and frequency of alleles in 169 control subjects, 96 LaOT1D subjects and 97 EOT1D subjects. Alleles shown have an allelic frequency ≥2.5% in patients or in controls. </a:t>
            </a:r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-significant. </a:t>
            </a:r>
          </a:p>
        </p:txBody>
      </p:sp>
    </p:spTree>
    <p:extLst>
      <p:ext uri="{BB962C8B-B14F-4D97-AF65-F5344CB8AC3E}">
        <p14:creationId xmlns:p14="http://schemas.microsoft.com/office/powerpoint/2010/main" val="119936816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625F6AFB-3904-9042-A32F-D0C7A6E8B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4189813"/>
              </p:ext>
            </p:extLst>
          </p:nvPr>
        </p:nvGraphicFramePr>
        <p:xfrm>
          <a:off x="188600" y="357424"/>
          <a:ext cx="6495229" cy="3550503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08035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659702">
                  <a:extLst>
                    <a:ext uri="{9D8B030D-6E8A-4147-A177-3AD203B41FA5}">
                      <a16:colId xmlns:a16="http://schemas.microsoft.com/office/drawing/2014/main" val="4018659096"/>
                    </a:ext>
                  </a:extLst>
                </a:gridCol>
                <a:gridCol w="684104">
                  <a:extLst>
                    <a:ext uri="{9D8B030D-6E8A-4147-A177-3AD203B41FA5}">
                      <a16:colId xmlns:a16="http://schemas.microsoft.com/office/drawing/2014/main" val="3935185497"/>
                    </a:ext>
                  </a:extLst>
                </a:gridCol>
                <a:gridCol w="699928">
                  <a:extLst>
                    <a:ext uri="{9D8B030D-6E8A-4147-A177-3AD203B41FA5}">
                      <a16:colId xmlns:a16="http://schemas.microsoft.com/office/drawing/2014/main" val="28079250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Haplotypes</a:t>
                      </a:r>
                    </a:p>
                    <a:p>
                      <a:pPr algn="ctr"/>
                      <a:r>
                        <a:rPr lang="en-PT" sz="800" b="0" dirty="0">
                          <a:latin typeface="Helvetica" pitchFamily="2" charset="0"/>
                        </a:rPr>
                        <a:t>DRB1-DQA1-DQB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309090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3:01-05:01-02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2 (6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0 (31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8 (40.2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5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8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9.6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9.6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.4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3.4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757459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1-03-03:02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 (1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7 (8.9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8 (9.3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1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5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2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740457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5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7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5.75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542016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2-03-03:02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2.4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1 (5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5 (7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5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73741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4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.4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350238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4-03-03:02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 (1.5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4.2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6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9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4096668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2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50</a:t>
                      </a:r>
                      <a:r>
                        <a:rPr lang="en-PT" sz="900" dirty="0">
                          <a:latin typeface="Helvetica" pitchFamily="2" charset="0"/>
                        </a:rPr>
                        <a:t>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US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6171014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5-03-03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 (2.1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6 (8.3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4.3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3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  <a:endParaRPr lang="en-US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5171040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NS</a:t>
                      </a:r>
                      <a:endParaRPr lang="en-US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060918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4:08-03-03:02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7 (8.8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1.7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5135621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&gt;32.3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7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1.3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249205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B0C8F04F-19D0-5746-B5A0-8839513C7D64}"/>
              </a:ext>
            </a:extLst>
          </p:cNvPr>
          <p:cNvSpPr/>
          <p:nvPr/>
        </p:nvSpPr>
        <p:spPr>
          <a:xfrm>
            <a:off x="117841" y="95814"/>
            <a:ext cx="679109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PT" sz="1100" dirty="0">
                <a:latin typeface="Helvetica" pitchFamily="2" charset="0"/>
              </a:rPr>
              <a:t>Table S4: DR3 and DR4 susceptibility haplotypes in LaOT1D and EOT1D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321CED8-7D25-FF4A-BDA6-A71269A77C37}"/>
              </a:ext>
            </a:extLst>
          </p:cNvPr>
          <p:cNvSpPr/>
          <p:nvPr/>
        </p:nvSpPr>
        <p:spPr>
          <a:xfrm>
            <a:off x="157719" y="3933766"/>
            <a:ext cx="655320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and frequency of haplotypes in 169 control subjects, 96 LaOT1D subjects and 97 EOT1D subjects. Haplotypes shown have a frequency ≥2.5% in patients or in controls. </a:t>
            </a:r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-significant. For haplotypes absent in healthy controls, the value of n=1 was considered to calculate the OR. </a:t>
            </a:r>
          </a:p>
        </p:txBody>
      </p:sp>
    </p:spTree>
    <p:extLst>
      <p:ext uri="{BB962C8B-B14F-4D97-AF65-F5344CB8AC3E}">
        <p14:creationId xmlns:p14="http://schemas.microsoft.com/office/powerpoint/2010/main" val="2018582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625F6AFB-3904-9042-A32F-D0C7A6E8B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09845674"/>
              </p:ext>
            </p:extLst>
          </p:nvPr>
        </p:nvGraphicFramePr>
        <p:xfrm>
          <a:off x="137795" y="417297"/>
          <a:ext cx="6606988" cy="5961528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81702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705394">
                  <a:extLst>
                    <a:ext uri="{9D8B030D-6E8A-4147-A177-3AD203B41FA5}">
                      <a16:colId xmlns:a16="http://schemas.microsoft.com/office/drawing/2014/main" val="4018659096"/>
                    </a:ext>
                  </a:extLst>
                </a:gridCol>
                <a:gridCol w="661852">
                  <a:extLst>
                    <a:ext uri="{9D8B030D-6E8A-4147-A177-3AD203B41FA5}">
                      <a16:colId xmlns:a16="http://schemas.microsoft.com/office/drawing/2014/main" val="3935185497"/>
                    </a:ext>
                  </a:extLst>
                </a:gridCol>
                <a:gridCol w="658772">
                  <a:extLst>
                    <a:ext uri="{9D8B030D-6E8A-4147-A177-3AD203B41FA5}">
                      <a16:colId xmlns:a16="http://schemas.microsoft.com/office/drawing/2014/main" val="28079250"/>
                    </a:ext>
                  </a:extLst>
                </a:gridCol>
                <a:gridCol w="824817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24817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24817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24817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Haplotypes</a:t>
                      </a:r>
                    </a:p>
                    <a:p>
                      <a:pPr algn="ctr"/>
                      <a:r>
                        <a:rPr lang="en-PT" sz="800" b="0" dirty="0">
                          <a:latin typeface="Helvetica" pitchFamily="2" charset="0"/>
                        </a:rPr>
                        <a:t>DRB1-DQA1-DQB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atien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01:01-01:01-05:01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7 (4.9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 (3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4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7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5893440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9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5311642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01:02-01:01-05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 (5.9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7 (3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 (3.1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6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9789078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5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4506842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7:01-02:01-02:01/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2:02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8 (14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4 (7.3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 (4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4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7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9172775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9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8.2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7176943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8:01-04:01-04:02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 (2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 (1.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2.9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7314369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447033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1:01-05:05-03:01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1 (6.2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 (2.1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3.3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86227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5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3.9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9133795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3:01-01:03-06:03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3 (6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6.07x</a:t>
                      </a:r>
                      <a:r>
                        <a:rPr lang="en-PT" sz="900" dirty="0">
                          <a:latin typeface="Helvetica" pitchFamily="2" charset="0"/>
                        </a:rPr>
                        <a:t>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3507710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95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676870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3:02-01:02-06:04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3 (3.8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 (1.0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6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71608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80792271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3:03-05:05-03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 (3.6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3.7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  <a:endParaRPr lang="en-PT" sz="900" baseline="0" dirty="0">
                        <a:latin typeface="Helvetica" pitchFamily="2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325676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1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4965429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4:01-01:01-05:03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3 (3.8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6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873335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.9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6405172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5:01-01:02-06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 (5.9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 (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 (0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.6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7.0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2273975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8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9.83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4.2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1473887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6:01-01:02-05:02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4 (4.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 (1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6 (3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37</a:t>
                      </a: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7981383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7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38170995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B0C8F04F-19D0-5746-B5A0-8839513C7D64}"/>
              </a:ext>
            </a:extLst>
          </p:cNvPr>
          <p:cNvSpPr/>
          <p:nvPr/>
        </p:nvSpPr>
        <p:spPr>
          <a:xfrm>
            <a:off x="182328" y="84160"/>
            <a:ext cx="6791093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PT" sz="1100" dirty="0">
                <a:latin typeface="Helvetica" pitchFamily="2" charset="0"/>
              </a:rPr>
              <a:t>Table S5: Protective DRB1-DQA1-DQB1 haplotypes in LaOT1D and EOT1D patients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4BDC72FA-F9DE-6CF2-994B-EFAA87D475A1}"/>
              </a:ext>
            </a:extLst>
          </p:cNvPr>
          <p:cNvSpPr/>
          <p:nvPr/>
        </p:nvSpPr>
        <p:spPr>
          <a:xfrm>
            <a:off x="137795" y="6378825"/>
            <a:ext cx="6577925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of alleles and frequency of alleles in 169 control subjects, 96 LaOT1D subjects and 97 EOT1D subjects. Haplotypes shown have a frequency ≥2.5% in patients or in controls. </a:t>
            </a:r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 significant. </a:t>
            </a:r>
          </a:p>
        </p:txBody>
      </p:sp>
    </p:spTree>
    <p:extLst>
      <p:ext uri="{BB962C8B-B14F-4D97-AF65-F5344CB8AC3E}">
        <p14:creationId xmlns:p14="http://schemas.microsoft.com/office/powerpoint/2010/main" val="30956973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2">
            <a:extLst>
              <a:ext uri="{FF2B5EF4-FFF2-40B4-BE49-F238E27FC236}">
                <a16:creationId xmlns:a16="http://schemas.microsoft.com/office/drawing/2014/main" id="{625F6AFB-3904-9042-A32F-D0C7A6E8B7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1211690"/>
              </p:ext>
            </p:extLst>
          </p:nvPr>
        </p:nvGraphicFramePr>
        <p:xfrm>
          <a:off x="1608685" y="754394"/>
          <a:ext cx="3640630" cy="3550503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208035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10865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Haplotypes</a:t>
                      </a:r>
                    </a:p>
                    <a:p>
                      <a:pPr algn="ctr"/>
                      <a:r>
                        <a:rPr lang="en-PT" sz="800" b="0" dirty="0">
                          <a:latin typeface="Helvetica" pitchFamily="2" charset="0"/>
                        </a:rPr>
                        <a:t>DRB1-DQA1-DQB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309090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3:01-05:01-02:01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4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1.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67574590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1-03-03:02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6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3740457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8.3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9542016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2-03-03:02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3.6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7737416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1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7350238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4-03-03:02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18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6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4096668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2.8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6171014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04:05-03-03:02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6.4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5171040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6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060918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4:08-03-03:02</a:t>
                      </a: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.81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5135621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13.6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dirty="0">
                          <a:latin typeface="Helvetica" pitchFamily="2" charset="0"/>
                        </a:rPr>
                        <a:t>&lt;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4249205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B0C8F04F-19D0-5746-B5A0-8839513C7D64}"/>
              </a:ext>
            </a:extLst>
          </p:cNvPr>
          <p:cNvSpPr/>
          <p:nvPr/>
        </p:nvSpPr>
        <p:spPr>
          <a:xfrm>
            <a:off x="109678" y="95814"/>
            <a:ext cx="6666680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1100" dirty="0">
                <a:latin typeface="Helvetica" pitchFamily="2" charset="0"/>
              </a:rPr>
              <a:t>Table S6: Genetic risk conferred by DR3 and DR4 haplotypes in LaOT1D and EOT1D, as determined by regularized binary logistic regression.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9321CED8-7D25-FF4A-BDA6-A71269A77C37}"/>
              </a:ext>
            </a:extLst>
          </p:cNvPr>
          <p:cNvSpPr/>
          <p:nvPr/>
        </p:nvSpPr>
        <p:spPr>
          <a:xfrm>
            <a:off x="1608685" y="4304897"/>
            <a:ext cx="3640630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PT" sz="900" dirty="0">
                <a:latin typeface="Helvetica" pitchFamily="2" charset="0"/>
              </a:rPr>
              <a:t>OR: Odds ratio, calculated using the formula: coefficient= ln(OR); p-values in binary logistic regression analysis are depicted. </a:t>
            </a:r>
            <a:r>
              <a:rPr lang="en-GB" sz="900" dirty="0">
                <a:latin typeface="Helvetica" pitchFamily="2" charset="0"/>
              </a:rPr>
              <a:t>Significant results are depicted in bold.</a:t>
            </a:r>
          </a:p>
        </p:txBody>
      </p:sp>
    </p:spTree>
    <p:extLst>
      <p:ext uri="{BB962C8B-B14F-4D97-AF65-F5344CB8AC3E}">
        <p14:creationId xmlns:p14="http://schemas.microsoft.com/office/powerpoint/2010/main" val="38925816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3E7C10B-ED62-C097-AFE7-645F4B41EE65}"/>
              </a:ext>
            </a:extLst>
          </p:cNvPr>
          <p:cNvSpPr txBox="1"/>
          <p:nvPr/>
        </p:nvSpPr>
        <p:spPr>
          <a:xfrm>
            <a:off x="102268" y="110107"/>
            <a:ext cx="34290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PT" sz="1000" dirty="0">
                <a:latin typeface="Helvetica" pitchFamily="2" charset="0"/>
              </a:rPr>
              <a:t>Table S7: Clinical characteristics of the patient groups.  </a:t>
            </a:r>
            <a:endParaRPr lang="en-PT" sz="1000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D087B92-4DCD-EBF8-60DE-1B687E019715}"/>
              </a:ext>
            </a:extLst>
          </p:cNvPr>
          <p:cNvSpPr txBox="1"/>
          <p:nvPr/>
        </p:nvSpPr>
        <p:spPr>
          <a:xfrm>
            <a:off x="102268" y="3168656"/>
            <a:ext cx="666253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dirty="0">
                <a:latin typeface="Helvetica" pitchFamily="2" charset="0"/>
              </a:rPr>
              <a:t>n: </a:t>
            </a:r>
            <a:r>
              <a:rPr lang="en-PT" sz="1000" dirty="0">
                <a:latin typeface="Helvetica" pitchFamily="2" charset="0"/>
              </a:rPr>
              <a:t>number of individuals with the indicated clinical characteristic; </a:t>
            </a:r>
            <a:r>
              <a:rPr lang="en-GB" sz="1000" dirty="0" err="1">
                <a:latin typeface="Helvetica" pitchFamily="2" charset="0"/>
              </a:rPr>
              <a:t>nt</a:t>
            </a:r>
            <a:r>
              <a:rPr lang="en-PT" sz="1000" dirty="0">
                <a:latin typeface="Helvetica" pitchFamily="2" charset="0"/>
              </a:rPr>
              <a:t>: number of individuals included in the analysis; sem: standard error of the mean; AIA: anti-insulin autoantibodies; HbA1C: </a:t>
            </a:r>
            <a:r>
              <a:rPr lang="en-GB" sz="1000" dirty="0">
                <a:latin typeface="Helvetica" pitchFamily="2" charset="0"/>
              </a:rPr>
              <a:t>Glycated haemoglobin; </a:t>
            </a:r>
            <a:r>
              <a:rPr lang="en-PT" sz="1000" dirty="0">
                <a:latin typeface="Helvetica" pitchFamily="2" charset="0"/>
              </a:rPr>
              <a:t>HbA1C 1Y: </a:t>
            </a:r>
            <a:r>
              <a:rPr lang="en-GB" sz="1000" dirty="0">
                <a:latin typeface="Helvetica" pitchFamily="2" charset="0"/>
              </a:rPr>
              <a:t>Glycated haemoglobin 1 year after diagnosis; NS, non significant; p-value calculated using Fisher´s exact test </a:t>
            </a:r>
            <a:r>
              <a:rPr lang="en-GB" sz="1000" baseline="30000" dirty="0">
                <a:latin typeface="Helvetica" pitchFamily="2" charset="0"/>
              </a:rPr>
              <a:t>(a)</a:t>
            </a:r>
            <a:r>
              <a:rPr lang="en-GB" sz="1000" dirty="0">
                <a:latin typeface="Helvetica" pitchFamily="2" charset="0"/>
              </a:rPr>
              <a:t> or two-tailed Mann-Whitney test </a:t>
            </a:r>
            <a:r>
              <a:rPr lang="en-GB" sz="1000" baseline="30000" dirty="0">
                <a:latin typeface="Helvetica" pitchFamily="2" charset="0"/>
              </a:rPr>
              <a:t>(b)</a:t>
            </a:r>
            <a:r>
              <a:rPr lang="en-GB" sz="1000" dirty="0">
                <a:latin typeface="Helvetica" pitchFamily="2" charset="0"/>
              </a:rPr>
              <a:t>. </a:t>
            </a:r>
            <a:endParaRPr lang="en-PT" sz="1000" dirty="0">
              <a:latin typeface="Helvetica" pitchFamily="2" charset="0"/>
            </a:endParaRPr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CD131019-C949-EF59-F4F7-266E31DCA2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77820036"/>
              </p:ext>
            </p:extLst>
          </p:nvPr>
        </p:nvGraphicFramePr>
        <p:xfrm>
          <a:off x="146109" y="464552"/>
          <a:ext cx="6618697" cy="222504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736275">
                  <a:extLst>
                    <a:ext uri="{9D8B030D-6E8A-4147-A177-3AD203B41FA5}">
                      <a16:colId xmlns:a16="http://schemas.microsoft.com/office/drawing/2014/main" val="2447706740"/>
                    </a:ext>
                  </a:extLst>
                </a:gridCol>
                <a:gridCol w="1979203">
                  <a:extLst>
                    <a:ext uri="{9D8B030D-6E8A-4147-A177-3AD203B41FA5}">
                      <a16:colId xmlns:a16="http://schemas.microsoft.com/office/drawing/2014/main" val="1787987480"/>
                    </a:ext>
                  </a:extLst>
                </a:gridCol>
                <a:gridCol w="2086489">
                  <a:extLst>
                    <a:ext uri="{9D8B030D-6E8A-4147-A177-3AD203B41FA5}">
                      <a16:colId xmlns:a16="http://schemas.microsoft.com/office/drawing/2014/main" val="3721362940"/>
                    </a:ext>
                  </a:extLst>
                </a:gridCol>
                <a:gridCol w="816730">
                  <a:extLst>
                    <a:ext uri="{9D8B030D-6E8A-4147-A177-3AD203B41FA5}">
                      <a16:colId xmlns:a16="http://schemas.microsoft.com/office/drawing/2014/main" val="3532951387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9387405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C-peptide at diagnos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(</a:t>
                      </a:r>
                      <a:r>
                        <a:rPr lang="en-PT" sz="900" b="0" dirty="0">
                          <a:latin typeface="Helvetica" pitchFamily="2" charset="0"/>
                        </a:rPr>
                        <a:t>mean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sem, </a:t>
                      </a:r>
                      <a:r>
                        <a:rPr lang="en-PT" sz="900" dirty="0">
                          <a:latin typeface="Helvetica" pitchFamily="2" charset="0"/>
                        </a:rPr>
                        <a:t>ng/ml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; [IQR]; nt</a:t>
                      </a:r>
                      <a:r>
                        <a:rPr lang="en-PT" sz="900" dirty="0">
                          <a:latin typeface="Helvetica" pitchFamily="2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.428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05; [0.20-0.60]; 32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0.326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06; [0.10-0.30]; 51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.9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 (b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2085814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AIA at diagnos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dirty="0">
                          <a:latin typeface="Helvetica" pitchFamily="2" charset="0"/>
                        </a:rPr>
                        <a:t>n/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5/6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0/8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>
                          <a:latin typeface="Helvetica" pitchFamily="2" charset="0"/>
                        </a:rPr>
                        <a:t>6.01x10</a:t>
                      </a:r>
                      <a:r>
                        <a:rPr lang="en-PT" sz="900" baseline="30000">
                          <a:latin typeface="Helvetica" pitchFamily="2" charset="0"/>
                        </a:rPr>
                        <a:t>-06 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(a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0688302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%HbA1c at diagnosis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(</a:t>
                      </a:r>
                      <a:r>
                        <a:rPr lang="en-PT" sz="900" b="0" dirty="0">
                          <a:latin typeface="Helvetica" pitchFamily="2" charset="0"/>
                        </a:rPr>
                        <a:t>mean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sem; [IQR]; nt</a:t>
                      </a:r>
                      <a:r>
                        <a:rPr lang="en-PT" sz="900" dirty="0">
                          <a:latin typeface="Helvetica" pitchFamily="2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1.45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45; [9.50-13.60]; 34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0.58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20; [9.40-11.60]; 69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4.4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 (b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0308727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%HbA1c 1Y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(</a:t>
                      </a:r>
                      <a:r>
                        <a:rPr lang="en-PT" sz="900" b="0" dirty="0">
                          <a:latin typeface="Helvetica" pitchFamily="2" charset="0"/>
                        </a:rPr>
                        <a:t>mean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sem; [IQR]; nt</a:t>
                      </a:r>
                      <a:r>
                        <a:rPr lang="en-PT" sz="900" dirty="0">
                          <a:latin typeface="Helvetica" pitchFamily="2" charset="0"/>
                        </a:rPr>
                        <a:t>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14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33; [7.20-8.6]; 31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8.47</a:t>
                      </a:r>
                      <a:r>
                        <a:rPr lang="en-PT" sz="900" b="0" baseline="0" dirty="0">
                          <a:latin typeface="Helvetica" pitchFamily="2" charset="0"/>
                        </a:rPr>
                        <a:t>±0.11; [7.80-9.28]; 80</a:t>
                      </a:r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.6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 (b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51562428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HbA1c 1Y&lt; 7.5%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0" dirty="0">
                          <a:latin typeface="Helvetica" pitchFamily="2" charset="0"/>
                        </a:rPr>
                        <a:t>n/nt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/2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2/6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.9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 (a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82491458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302705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1DB7585-D989-7FE4-12B8-BAC5BFBDE7F9}"/>
              </a:ext>
            </a:extLst>
          </p:cNvPr>
          <p:cNvSpPr txBox="1"/>
          <p:nvPr/>
        </p:nvSpPr>
        <p:spPr>
          <a:xfrm>
            <a:off x="0" y="121724"/>
            <a:ext cx="67136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Helvetica" pitchFamily="2" charset="0"/>
                <a:cs typeface="Arial" panose="020B0604020202020204" pitchFamily="34" charset="0"/>
              </a:rPr>
              <a:t>Table S8: </a:t>
            </a:r>
            <a:r>
              <a:rPr lang="en-PT" sz="1100" dirty="0">
                <a:latin typeface="Helvetica" pitchFamily="2" charset="0"/>
              </a:rPr>
              <a:t>Susceptible and protective alleles defined by HLA-DQA1 position 52 in EOT1D and LaOT1D.</a:t>
            </a:r>
            <a:r>
              <a:rPr lang="en-GB" sz="1100" dirty="0">
                <a:latin typeface="Helvetica" pitchFamily="2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Table 2">
            <a:extLst>
              <a:ext uri="{FF2B5EF4-FFF2-40B4-BE49-F238E27FC236}">
                <a16:creationId xmlns:a16="http://schemas.microsoft.com/office/drawing/2014/main" id="{9A082C03-9F7C-BCE1-8A1A-7FDBDC18F0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2231493"/>
              </p:ext>
            </p:extLst>
          </p:nvPr>
        </p:nvGraphicFramePr>
        <p:xfrm>
          <a:off x="91912" y="452719"/>
          <a:ext cx="6674171" cy="3229161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60177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708365">
                  <a:extLst>
                    <a:ext uri="{9D8B030D-6E8A-4147-A177-3AD203B41FA5}">
                      <a16:colId xmlns:a16="http://schemas.microsoft.com/office/drawing/2014/main" val="3113448806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3087413258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267998112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42091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26454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Haplotype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DQA1 pos5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dirty="0">
                          <a:latin typeface="Helvetica" pitchFamily="2" charset="0"/>
                        </a:rPr>
                        <a:t>Risk allele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912005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R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37 (40.5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42 (74.0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52 (78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.17</a:t>
                      </a:r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7.0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4</a:t>
                      </a:r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7.0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.31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3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7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5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535227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dirty="0">
                          <a:latin typeface="Helvetica" pitchFamily="2" charset="0"/>
                        </a:rPr>
                        <a:t>Protective allele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027171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H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53 (15.7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8 (9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0 (5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5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4.64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72909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2.3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4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4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309666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48 (43.8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32 (16.7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32 (16.5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6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00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7.02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515676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5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5.9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1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4.73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3398386"/>
                  </a:ext>
                </a:extLst>
              </a:tr>
              <a:tr h="248397">
                <a:tc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8340127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R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neg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201 (59.5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50 (26.0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42 (21.6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2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7.01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4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baseline="0" dirty="0">
                          <a:latin typeface="Helvetica" pitchFamily="2" charset="0"/>
                        </a:rPr>
                        <a:t>7.01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65748201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1.3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1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="1" baseline="0" dirty="0">
                          <a:latin typeface="Helvetica" pitchFamily="2" charset="0"/>
                        </a:rPr>
                        <a:t>1.5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6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26859323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4A34736F-376A-B202-26E3-281C5D23FBFB}"/>
              </a:ext>
            </a:extLst>
          </p:cNvPr>
          <p:cNvSpPr txBox="1"/>
          <p:nvPr/>
        </p:nvSpPr>
        <p:spPr>
          <a:xfrm>
            <a:off x="-3" y="3751265"/>
            <a:ext cx="6858000" cy="5078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dirty="0">
                <a:latin typeface="Helvetica" pitchFamily="2" charset="0"/>
              </a:rPr>
              <a:t>n (%): number and frequency of alleles in 169 control subjects, 96 LaOT1D subjects and 97 EOT1D subjects. </a:t>
            </a:r>
            <a:r>
              <a:rPr lang="en-PT" sz="900" dirty="0">
                <a:latin typeface="Helvetica" pitchFamily="2" charset="0"/>
              </a:rPr>
              <a:t>OR: Odds ratio; p-value, uncorrected; p-value (corrected), </a:t>
            </a:r>
            <a:r>
              <a:rPr lang="en-GB" sz="900" dirty="0">
                <a:latin typeface="Helvetica" pitchFamily="2" charset="0"/>
              </a:rPr>
              <a:t>Holm-Bonferroni multi-comparison </a:t>
            </a:r>
            <a:r>
              <a:rPr lang="en-PT" sz="900" dirty="0">
                <a:latin typeface="Helvetica" pitchFamily="2" charset="0"/>
              </a:rPr>
              <a:t>correction</a:t>
            </a:r>
            <a:r>
              <a:rPr lang="en-GB" sz="900" dirty="0">
                <a:latin typeface="Helvetica" pitchFamily="2" charset="0"/>
              </a:rPr>
              <a:t>. Significant results are depicted in bold. NS, non significant. </a:t>
            </a:r>
          </a:p>
        </p:txBody>
      </p:sp>
    </p:spTree>
    <p:extLst>
      <p:ext uri="{BB962C8B-B14F-4D97-AF65-F5344CB8AC3E}">
        <p14:creationId xmlns:p14="http://schemas.microsoft.com/office/powerpoint/2010/main" val="23628371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AE29642-18EF-5B87-82D5-07EC9C73A06B}"/>
              </a:ext>
            </a:extLst>
          </p:cNvPr>
          <p:cNvSpPr txBox="1"/>
          <p:nvPr/>
        </p:nvSpPr>
        <p:spPr>
          <a:xfrm>
            <a:off x="0" y="121724"/>
            <a:ext cx="671369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dirty="0">
                <a:latin typeface="Helvetica" pitchFamily="2" charset="0"/>
                <a:cs typeface="Arial" panose="020B0604020202020204" pitchFamily="34" charset="0"/>
              </a:rPr>
              <a:t>Table S9: </a:t>
            </a:r>
            <a:r>
              <a:rPr lang="en-PT" sz="1100" dirty="0">
                <a:latin typeface="Helvetica" pitchFamily="2" charset="0"/>
              </a:rPr>
              <a:t>Susceptible and protective alleles defined by HLA-DQB1 position 57 in EOT1D and LaOT1D.</a:t>
            </a:r>
            <a:r>
              <a:rPr lang="en-GB" sz="1100" dirty="0">
                <a:latin typeface="Helvetica" pitchFamily="2" charset="0"/>
                <a:cs typeface="Arial" panose="020B0604020202020204" pitchFamily="34" charset="0"/>
              </a:rPr>
              <a:t> </a:t>
            </a:r>
          </a:p>
        </p:txBody>
      </p:sp>
      <p:graphicFrame>
        <p:nvGraphicFramePr>
          <p:cNvPr id="5" name="Table 2">
            <a:extLst>
              <a:ext uri="{FF2B5EF4-FFF2-40B4-BE49-F238E27FC236}">
                <a16:creationId xmlns:a16="http://schemas.microsoft.com/office/drawing/2014/main" id="{49314A42-3943-0B83-2CE8-9E45A90CD28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4959789"/>
              </p:ext>
            </p:extLst>
          </p:nvPr>
        </p:nvGraphicFramePr>
        <p:xfrm>
          <a:off x="91912" y="452719"/>
          <a:ext cx="6674171" cy="3229161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960177">
                  <a:extLst>
                    <a:ext uri="{9D8B030D-6E8A-4147-A177-3AD203B41FA5}">
                      <a16:colId xmlns:a16="http://schemas.microsoft.com/office/drawing/2014/main" val="1980486418"/>
                    </a:ext>
                  </a:extLst>
                </a:gridCol>
                <a:gridCol w="708365">
                  <a:extLst>
                    <a:ext uri="{9D8B030D-6E8A-4147-A177-3AD203B41FA5}">
                      <a16:colId xmlns:a16="http://schemas.microsoft.com/office/drawing/2014/main" val="3113448806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3087413258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267998112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1165780962"/>
                    </a:ext>
                  </a:extLst>
                </a:gridCol>
                <a:gridCol w="834271">
                  <a:extLst>
                    <a:ext uri="{9D8B030D-6E8A-4147-A177-3AD203B41FA5}">
                      <a16:colId xmlns:a16="http://schemas.microsoft.com/office/drawing/2014/main" val="2672720573"/>
                    </a:ext>
                  </a:extLst>
                </a:gridCol>
                <a:gridCol w="842091">
                  <a:extLst>
                    <a:ext uri="{9D8B030D-6E8A-4147-A177-3AD203B41FA5}">
                      <a16:colId xmlns:a16="http://schemas.microsoft.com/office/drawing/2014/main" val="2457176690"/>
                    </a:ext>
                  </a:extLst>
                </a:gridCol>
                <a:gridCol w="826454">
                  <a:extLst>
                    <a:ext uri="{9D8B030D-6E8A-4147-A177-3AD203B41FA5}">
                      <a16:colId xmlns:a16="http://schemas.microsoft.com/office/drawing/2014/main" val="1558205466"/>
                    </a:ext>
                  </a:extLst>
                </a:gridCol>
              </a:tblGrid>
              <a:tr h="496794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Haplotype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DQB1 pos5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Controls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La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EOT1D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n (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Subject group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OR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p-value</a:t>
                      </a:r>
                    </a:p>
                    <a:p>
                      <a:pPr algn="ctr"/>
                      <a:r>
                        <a:rPr lang="en-PT" sz="1000" b="0" dirty="0">
                          <a:latin typeface="Helvetica" pitchFamily="2" charset="0"/>
                        </a:rPr>
                        <a:t>(corrected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000115515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dirty="0">
                          <a:latin typeface="Helvetica" pitchFamily="2" charset="0"/>
                        </a:rPr>
                        <a:t>Risk allele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69120055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A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06 (31.4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51 (78.6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56 (80.4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.06</a:t>
                      </a:r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baseline="0" dirty="0">
                          <a:latin typeface="Helvetica" pitchFamily="2" charset="0"/>
                        </a:rPr>
                        <a:t>1.76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6</a:t>
                      </a:r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2.4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5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31988287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8.99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1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8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78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7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9535227"/>
                  </a:ext>
                </a:extLst>
              </a:tr>
              <a:tr h="248397">
                <a:tc>
                  <a:txBody>
                    <a:bodyPr/>
                    <a:lstStyle/>
                    <a:p>
                      <a:pPr algn="ctr"/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5560669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neg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93 (57.1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78 (92.7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82 (93.8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9.55</a:t>
                      </a:r>
                    </a:p>
                  </a:txBody>
                  <a:tcPr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5.9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6.5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9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70810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1.39</a:t>
                      </a:r>
                    </a:p>
                  </a:txBody>
                  <a:tcP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8.7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1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88108352"/>
                  </a:ext>
                </a:extLst>
              </a:tr>
              <a:tr h="248397">
                <a:tc gridSpan="8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1000" b="0" dirty="0">
                          <a:latin typeface="Helvetica" pitchFamily="2" charset="0"/>
                        </a:rPr>
                        <a:t>Protective alleles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dirty="0">
                        <a:solidFill>
                          <a:schemeClr val="tx1"/>
                        </a:solidFill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PT" sz="900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PT" sz="900" b="1" baseline="300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6027171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D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45 (42.9)</a:t>
                      </a:r>
                    </a:p>
                  </a:txBody>
                  <a:tcPr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14 (7.3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2 (6.2)</a:t>
                      </a: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1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5.99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6.59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19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7290944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09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8.78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2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14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20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53096666"/>
                  </a:ext>
                </a:extLst>
              </a:tr>
              <a:tr h="248397"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V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69 (20.4)</a:t>
                      </a: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23 (12.0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19 (9.8)</a:t>
                      </a: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PT" sz="900" dirty="0">
                          <a:latin typeface="Helvetica" pitchFamily="2" charset="0"/>
                        </a:rPr>
                        <a:t>LaOT1D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53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67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NS</a:t>
                      </a:r>
                    </a:p>
                  </a:txBody>
                  <a:tcPr anchor="ctr"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5156769"/>
                  </a:ext>
                </a:extLst>
              </a:tr>
              <a:tr h="248397"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 anchor="ctr"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PT" sz="900" dirty="0">
                        <a:latin typeface="Helvetica" pitchFamily="2" charset="0"/>
                      </a:endParaRPr>
                    </a:p>
                  </a:txBody>
                  <a:tcPr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latin typeface="Helvetica" pitchFamily="2" charset="0"/>
                        </a:rPr>
                        <a:t>EOT1D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dirty="0">
                          <a:solidFill>
                            <a:schemeClr val="tx1"/>
                          </a:solidFill>
                          <a:latin typeface="Helvetica" pitchFamily="2" charset="0"/>
                        </a:rPr>
                        <a:t>0.4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aseline="0" dirty="0">
                          <a:latin typeface="Helvetica" pitchFamily="2" charset="0"/>
                        </a:rPr>
                        <a:t>1.52x10</a:t>
                      </a:r>
                      <a:r>
                        <a:rPr lang="en-PT" sz="900" baseline="30000" dirty="0">
                          <a:latin typeface="Helvetica" pitchFamily="2" charset="0"/>
                        </a:rPr>
                        <a:t>-03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PT" sz="900" b="1" baseline="0" dirty="0">
                          <a:latin typeface="Helvetica" pitchFamily="2" charset="0"/>
                        </a:rPr>
                        <a:t>1.37x10</a:t>
                      </a:r>
                      <a:r>
                        <a:rPr lang="en-PT" sz="900" b="1" baseline="30000" dirty="0">
                          <a:latin typeface="Helvetica" pitchFamily="2" charset="0"/>
                        </a:rPr>
                        <a:t>-02</a:t>
                      </a:r>
                    </a:p>
                  </a:txBody>
                  <a:tcPr anchor="ctr"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03398386"/>
                  </a:ext>
                </a:extLst>
              </a:tr>
            </a:tbl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0B2340A2-ED4E-3A61-20C4-3F4DDB468AE4}"/>
              </a:ext>
            </a:extLst>
          </p:cNvPr>
          <p:cNvSpPr txBox="1"/>
          <p:nvPr/>
        </p:nvSpPr>
        <p:spPr>
          <a:xfrm>
            <a:off x="91912" y="3751265"/>
            <a:ext cx="6713697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1000" dirty="0">
                <a:latin typeface="Helvetica" pitchFamily="2" charset="0"/>
              </a:rPr>
              <a:t>n (%): number and frequency of alleles in 169 control subjects, 96 LaOT1D subjects and 97 EOT1D subjects. </a:t>
            </a:r>
            <a:r>
              <a:rPr lang="en-PT" sz="1000" dirty="0">
                <a:latin typeface="Helvetica" pitchFamily="2" charset="0"/>
              </a:rPr>
              <a:t>OR: Odds ratio; p-value, uncorrected; p-value (corrected), </a:t>
            </a:r>
            <a:r>
              <a:rPr lang="en-GB" sz="1000" dirty="0">
                <a:latin typeface="Helvetica" pitchFamily="2" charset="0"/>
              </a:rPr>
              <a:t>Holm-Bonferroni multi-comparison </a:t>
            </a:r>
            <a:r>
              <a:rPr lang="en-PT" sz="1000" dirty="0">
                <a:latin typeface="Helvetica" pitchFamily="2" charset="0"/>
              </a:rPr>
              <a:t>correction</a:t>
            </a:r>
            <a:r>
              <a:rPr lang="en-GB" sz="1000" dirty="0">
                <a:latin typeface="Helvetica" pitchFamily="2" charset="0"/>
              </a:rPr>
              <a:t>. Significant results are depicted in bold. NS, non significant. </a:t>
            </a:r>
          </a:p>
        </p:txBody>
      </p:sp>
    </p:spTree>
    <p:extLst>
      <p:ext uri="{BB962C8B-B14F-4D97-AF65-F5344CB8AC3E}">
        <p14:creationId xmlns:p14="http://schemas.microsoft.com/office/powerpoint/2010/main" val="2551797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798</TotalTime>
  <Words>2394</Words>
  <Application>Microsoft Macintosh PowerPoint</Application>
  <PresentationFormat>A4 Paper (210x297 mm)</PresentationFormat>
  <Paragraphs>955</Paragraphs>
  <Slides>10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Iris Caramalho</cp:lastModifiedBy>
  <cp:revision>686</cp:revision>
  <cp:lastPrinted>2023-06-01T10:50:19Z</cp:lastPrinted>
  <dcterms:created xsi:type="dcterms:W3CDTF">2020-07-29T09:59:49Z</dcterms:created>
  <dcterms:modified xsi:type="dcterms:W3CDTF">2023-07-23T09:56:31Z</dcterms:modified>
</cp:coreProperties>
</file>